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2849811-A0AF-4659-89DE-3B135922C444}" v="1" dt="2025-11-05T13:29:27.13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1203" y="5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ève Houle" userId="84c369079bb2ec68" providerId="LiveId" clId="{B2849811-A0AF-4659-89DE-3B135922C444}"/>
    <pc:docChg chg="modSld">
      <pc:chgData name="Mariève Houle" userId="84c369079bb2ec68" providerId="LiveId" clId="{B2849811-A0AF-4659-89DE-3B135922C444}" dt="2025-11-05T13:29:27.137" v="33" actId="164"/>
      <pc:docMkLst>
        <pc:docMk/>
      </pc:docMkLst>
      <pc:sldChg chg="addSp modSp mod">
        <pc:chgData name="Mariève Houle" userId="84c369079bb2ec68" providerId="LiveId" clId="{B2849811-A0AF-4659-89DE-3B135922C444}" dt="2025-11-05T13:29:27.137" v="33" actId="164"/>
        <pc:sldMkLst>
          <pc:docMk/>
          <pc:sldMk cId="1477447291" sldId="256"/>
        </pc:sldMkLst>
        <pc:spChg chg="add mod">
          <ac:chgData name="Mariève Houle" userId="84c369079bb2ec68" providerId="LiveId" clId="{B2849811-A0AF-4659-89DE-3B135922C444}" dt="2025-11-05T13:29:27.137" v="33" actId="164"/>
          <ac:spMkLst>
            <pc:docMk/>
            <pc:sldMk cId="1477447291" sldId="256"/>
            <ac:spMk id="3" creationId="{91FC0308-9889-8389-C28C-54B265B76289}"/>
          </ac:spMkLst>
        </pc:spChg>
        <pc:spChg chg="mod">
          <ac:chgData name="Mariève Houle" userId="84c369079bb2ec68" providerId="LiveId" clId="{B2849811-A0AF-4659-89DE-3B135922C444}" dt="2025-11-05T13:29:27.137" v="33" actId="164"/>
          <ac:spMkLst>
            <pc:docMk/>
            <pc:sldMk cId="1477447291" sldId="256"/>
            <ac:spMk id="4" creationId="{00000000-0000-0000-0000-000000000000}"/>
          </ac:spMkLst>
        </pc:spChg>
        <pc:spChg chg="mod">
          <ac:chgData name="Mariève Houle" userId="84c369079bb2ec68" providerId="LiveId" clId="{B2849811-A0AF-4659-89DE-3B135922C444}" dt="2025-11-05T13:29:27.137" v="33" actId="164"/>
          <ac:spMkLst>
            <pc:docMk/>
            <pc:sldMk cId="1477447291" sldId="256"/>
            <ac:spMk id="11" creationId="{00000000-0000-0000-0000-000000000000}"/>
          </ac:spMkLst>
        </pc:spChg>
        <pc:grpChg chg="mod">
          <ac:chgData name="Mariève Houle" userId="84c369079bb2ec68" providerId="LiveId" clId="{B2849811-A0AF-4659-89DE-3B135922C444}" dt="2025-11-05T13:29:27.137" v="33" actId="164"/>
          <ac:grpSpMkLst>
            <pc:docMk/>
            <pc:sldMk cId="1477447291" sldId="256"/>
            <ac:grpSpMk id="6" creationId="{00000000-0000-0000-0000-000000000000}"/>
          </ac:grpSpMkLst>
        </pc:grpChg>
        <pc:grpChg chg="mod">
          <ac:chgData name="Mariève Houle" userId="84c369079bb2ec68" providerId="LiveId" clId="{B2849811-A0AF-4659-89DE-3B135922C444}" dt="2025-11-05T13:29:27.137" v="33" actId="164"/>
          <ac:grpSpMkLst>
            <pc:docMk/>
            <pc:sldMk cId="1477447291" sldId="256"/>
            <ac:grpSpMk id="7" creationId="{00000000-0000-0000-0000-000000000000}"/>
          </ac:grpSpMkLst>
        </pc:grpChg>
        <pc:grpChg chg="add mod">
          <ac:chgData name="Mariève Houle" userId="84c369079bb2ec68" providerId="LiveId" clId="{B2849811-A0AF-4659-89DE-3B135922C444}" dt="2025-11-05T13:29:27.137" v="33" actId="164"/>
          <ac:grpSpMkLst>
            <pc:docMk/>
            <pc:sldMk cId="1477447291" sldId="256"/>
            <ac:grpSpMk id="8" creationId="{C001B9DF-704C-04E7-4C4F-05BA82D9C2F3}"/>
          </ac:grpSpMkLst>
        </pc:grpChg>
      </pc:sldChg>
    </pc:docChg>
  </pc:docChgLst>
  <pc:docChgLst>
    <pc:chgData name="Mariève Houle" userId="84c369079bb2ec68" providerId="LiveId" clId="{1A0D16A2-EED3-431F-869C-B111F7D43745}"/>
    <pc:docChg chg="modSld">
      <pc:chgData name="Mariève Houle" userId="84c369079bb2ec68" providerId="LiveId" clId="{1A0D16A2-EED3-431F-869C-B111F7D43745}" dt="2025-10-02T12:54:01.732" v="0" actId="207"/>
      <pc:docMkLst>
        <pc:docMk/>
      </pc:docMkLst>
      <pc:sldChg chg="modSp mod">
        <pc:chgData name="Mariève Houle" userId="84c369079bb2ec68" providerId="LiveId" clId="{1A0D16A2-EED3-431F-869C-B111F7D43745}" dt="2025-10-02T12:54:01.732" v="0" actId="207"/>
        <pc:sldMkLst>
          <pc:docMk/>
          <pc:sldMk cId="1477447291" sldId="256"/>
        </pc:sldMkLst>
        <pc:spChg chg="mod">
          <ac:chgData name="Mariève Houle" userId="84c369079bb2ec68" providerId="LiveId" clId="{1A0D16A2-EED3-431F-869C-B111F7D43745}" dt="2025-10-02T12:54:01.732" v="0" actId="207"/>
          <ac:spMkLst>
            <pc:docMk/>
            <pc:sldMk cId="1477447291" sldId="256"/>
            <ac:spMk id="11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3ABF01-1C99-46B9-A83B-F065FC5C4FC7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F0EFBF-3717-4164-A90C-18DA99F0B2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36887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0F0EFBF-3717-4164-A90C-18DA99F0B221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3975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1446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7848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8744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6288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8664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331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461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0100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236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3948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7257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DB103A-05D2-4CAF-BBE3-A3148400D96C}" type="datetimeFigureOut">
              <a:rPr lang="fr-FR" smtClean="0"/>
              <a:t>05/1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22F263-92D0-463E-94A1-749BC25E03B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7969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>
            <a:extLst>
              <a:ext uri="{FF2B5EF4-FFF2-40B4-BE49-F238E27FC236}">
                <a16:creationId xmlns:a16="http://schemas.microsoft.com/office/drawing/2014/main" id="{C001B9DF-704C-04E7-4C4F-05BA82D9C2F3}"/>
              </a:ext>
            </a:extLst>
          </p:cNvPr>
          <p:cNvGrpSpPr/>
          <p:nvPr/>
        </p:nvGrpSpPr>
        <p:grpSpPr>
          <a:xfrm>
            <a:off x="-3247" y="172828"/>
            <a:ext cx="9257673" cy="6548939"/>
            <a:chOff x="-3247" y="172828"/>
            <a:chExt cx="9257673" cy="6548939"/>
          </a:xfrm>
        </p:grpSpPr>
        <p:sp>
          <p:nvSpPr>
            <p:cNvPr id="4" name="ZoneTexte 3"/>
            <p:cNvSpPr txBox="1"/>
            <p:nvPr/>
          </p:nvSpPr>
          <p:spPr>
            <a:xfrm>
              <a:off x="380893" y="172828"/>
              <a:ext cx="8524045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 err="1"/>
                <a:t>Absolute</a:t>
              </a:r>
              <a:r>
                <a:rPr lang="fr-FR" dirty="0"/>
                <a:t> TcpO2 at </a:t>
              </a:r>
              <a:r>
                <a:rPr lang="fr-FR" dirty="0" err="1"/>
                <a:t>rest</a:t>
              </a:r>
              <a:r>
                <a:rPr lang="fr-FR" dirty="0"/>
                <a:t> (</a:t>
              </a:r>
              <a:r>
                <a:rPr lang="fr-FR" dirty="0" err="1"/>
                <a:t>mmHg</a:t>
              </a:r>
              <a:r>
                <a:rPr lang="fr-FR" dirty="0"/>
                <a:t>)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366085" y="3212976"/>
              <a:ext cx="8524045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dirty="0"/>
                <a:t>DROPmin values at </a:t>
              </a:r>
              <a:r>
                <a:rPr lang="fr-FR" dirty="0" err="1"/>
                <a:t>exercise</a:t>
              </a:r>
              <a:r>
                <a:rPr lang="fr-FR" dirty="0"/>
                <a:t> (</a:t>
              </a:r>
              <a:r>
                <a:rPr lang="fr-FR" dirty="0" err="1"/>
                <a:t>mmHg</a:t>
              </a:r>
              <a:r>
                <a:rPr lang="fr-FR" dirty="0"/>
                <a:t>)</a:t>
              </a:r>
            </a:p>
          </p:txBody>
        </p:sp>
        <p:grpSp>
          <p:nvGrpSpPr>
            <p:cNvPr id="7" name="Groupe 6"/>
            <p:cNvGrpSpPr/>
            <p:nvPr/>
          </p:nvGrpSpPr>
          <p:grpSpPr>
            <a:xfrm>
              <a:off x="-3246" y="647391"/>
              <a:ext cx="8876468" cy="2457982"/>
              <a:chOff x="-3246" y="647391"/>
              <a:chExt cx="8876468" cy="2457982"/>
            </a:xfrm>
          </p:grpSpPr>
          <p:sp>
            <p:nvSpPr>
              <p:cNvPr id="5" name="ZoneTexte 4"/>
              <p:cNvSpPr txBox="1"/>
              <p:nvPr/>
            </p:nvSpPr>
            <p:spPr>
              <a:xfrm rot="16200000">
                <a:off x="-1047571" y="1691716"/>
                <a:ext cx="245798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 err="1"/>
                  <a:t>Number</a:t>
                </a:r>
                <a:r>
                  <a:rPr lang="fr-FR" dirty="0"/>
                  <a:t> of observations</a:t>
                </a:r>
              </a:p>
            </p:txBody>
          </p:sp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46885" y="678149"/>
                <a:ext cx="2726337" cy="2427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3" name="Picture 9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39411" y="662770"/>
                <a:ext cx="2726337" cy="2427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4" name="Picture 10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0359" y="678149"/>
                <a:ext cx="2726337" cy="24272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6" name="Groupe 5"/>
            <p:cNvGrpSpPr/>
            <p:nvPr/>
          </p:nvGrpSpPr>
          <p:grpSpPr>
            <a:xfrm>
              <a:off x="-3247" y="3717032"/>
              <a:ext cx="8876469" cy="2488215"/>
              <a:chOff x="-3247" y="3717032"/>
              <a:chExt cx="8876469" cy="2488215"/>
            </a:xfrm>
          </p:grpSpPr>
          <p:sp>
            <p:nvSpPr>
              <p:cNvPr id="13" name="ZoneTexte 12"/>
              <p:cNvSpPr txBox="1"/>
              <p:nvPr/>
            </p:nvSpPr>
            <p:spPr>
              <a:xfrm rot="16200000">
                <a:off x="-1047572" y="4761357"/>
                <a:ext cx="245798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 err="1"/>
                  <a:t>Number</a:t>
                </a:r>
                <a:r>
                  <a:rPr lang="fr-FR" dirty="0"/>
                  <a:t> of observations</a:t>
                </a:r>
              </a:p>
            </p:txBody>
          </p:sp>
          <p:pic>
            <p:nvPicPr>
              <p:cNvPr id="1035" name="Picture 11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3435" y="3773743"/>
                <a:ext cx="2738537" cy="24315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6" name="Picture 12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84372" y="3760274"/>
                <a:ext cx="2738537" cy="24315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7" name="Picture 13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34685" y="3773743"/>
                <a:ext cx="2738537" cy="24315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91FC0308-9889-8389-C28C-54B265B76289}"/>
                </a:ext>
              </a:extLst>
            </p:cNvPr>
            <p:cNvSpPr txBox="1"/>
            <p:nvPr/>
          </p:nvSpPr>
          <p:spPr>
            <a:xfrm>
              <a:off x="181418" y="6383213"/>
              <a:ext cx="9073008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le 2. 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solute TcPO</a:t>
              </a:r>
              <a:r>
                <a:rPr lang="en-US" sz="16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t rest and </a:t>
              </a:r>
              <a:r>
                <a:rPr lang="en-U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ROPmin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alues for each location (buttock, thigh, calf)</a:t>
              </a:r>
              <a:endParaRPr lang="fr-CA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7744729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42</Words>
  <Application>Microsoft Office PowerPoint</Application>
  <PresentationFormat>Affichage à l'écran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>Centre Hospitalier Universitaire d'Anger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BRAHAM PIERRE</dc:creator>
  <cp:lastModifiedBy>Mariève Houle</cp:lastModifiedBy>
  <cp:revision>3</cp:revision>
  <dcterms:created xsi:type="dcterms:W3CDTF">2025-10-02T09:30:38Z</dcterms:created>
  <dcterms:modified xsi:type="dcterms:W3CDTF">2025-11-05T13:29:28Z</dcterms:modified>
</cp:coreProperties>
</file>